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60" d="100"/>
          <a:sy n="60" d="100"/>
        </p:scale>
        <p:origin x="2558" y="4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5/10/relationships/revisionInfo" Target="revisionInfo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ysuzu\Dropbox\HRH1&#12487;&#12540;&#12479;\GFP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C$2</c:f>
              <c:strCache>
                <c:ptCount val="1"/>
                <c:pt idx="0">
                  <c:v>fluorescenc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D$3:$D$5</c:f>
                <c:numCache>
                  <c:formatCode>General</c:formatCode>
                  <c:ptCount val="3"/>
                  <c:pt idx="0">
                    <c:v>4783.6148233086014</c:v>
                  </c:pt>
                  <c:pt idx="1">
                    <c:v>1328.2813875246634</c:v>
                  </c:pt>
                  <c:pt idx="2">
                    <c:v>11154.539200602498</c:v>
                  </c:pt>
                </c:numCache>
              </c:numRef>
            </c:plus>
            <c:minus>
              <c:numRef>
                <c:f>Sheet1!$D$3:$D$5</c:f>
                <c:numCache>
                  <c:formatCode>General</c:formatCode>
                  <c:ptCount val="3"/>
                  <c:pt idx="0">
                    <c:v>4783.6148233086014</c:v>
                  </c:pt>
                  <c:pt idx="1">
                    <c:v>1328.2813875246634</c:v>
                  </c:pt>
                  <c:pt idx="2">
                    <c:v>11154.539200602498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3:$B$5</c:f>
              <c:strCache>
                <c:ptCount val="3"/>
                <c:pt idx="0">
                  <c:v>EGFP</c:v>
                </c:pt>
                <c:pt idx="1">
                  <c:v>EGFP+standard asolectin liposomes</c:v>
                </c:pt>
                <c:pt idx="2">
                  <c:v>EGFP+20% glycerosomes</c:v>
                </c:pt>
              </c:strCache>
            </c:strRef>
          </c:cat>
          <c:val>
            <c:numRef>
              <c:f>Sheet1!$C$3:$C$5</c:f>
              <c:numCache>
                <c:formatCode>General</c:formatCode>
                <c:ptCount val="3"/>
                <c:pt idx="0">
                  <c:v>355398.33333333331</c:v>
                </c:pt>
                <c:pt idx="1">
                  <c:v>381745.66666666669</c:v>
                </c:pt>
                <c:pt idx="2">
                  <c:v>274154.33333333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D84-4DA9-8698-0DDF1ADCE3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95856128"/>
        <c:axId val="95857664"/>
      </c:barChart>
      <c:catAx>
        <c:axId val="95856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857664"/>
        <c:crosses val="autoZero"/>
        <c:auto val="1"/>
        <c:lblAlgn val="ctr"/>
        <c:lblOffset val="100"/>
        <c:noMultiLvlLbl val="0"/>
      </c:catAx>
      <c:valAx>
        <c:axId val="958576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58561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9357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2282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3154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7752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7702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3389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5034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7748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1404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96505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3379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53391-9F83-4479-BF36-E703D7F2CAB7}" type="datetimeFigureOut">
              <a:rPr kumimoji="1" lang="ja-JP" altLang="en-US" smtClean="0"/>
              <a:t>2018/2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F7600C-AD65-4572-A9EE-09D73EEB1A6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53001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414F0F8-78B2-4D22-9A88-70CD8DA55DD5}"/>
              </a:ext>
            </a:extLst>
          </p:cNvPr>
          <p:cNvSpPr txBox="1"/>
          <p:nvPr/>
        </p:nvSpPr>
        <p:spPr>
          <a:xfrm>
            <a:off x="514350" y="4519533"/>
            <a:ext cx="58293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: Effect of </a:t>
            </a:r>
            <a:r>
              <a:rPr kumimoji="1"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erosomes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EGFP synthesis.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the effects of standard liposomes and 20%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erosome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the synthesis of EGFP. 20%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erosome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lightly inhibit the synthesis of EGFP.</a:t>
            </a:r>
          </a:p>
          <a:p>
            <a:pPr algn="just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GFP vs. EGFP + 20%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erosome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 = 0.00055 and EGFP + standard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olectin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posomes vs. EGFP+20%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erosomes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 = 0.00011 (Bonferroni multiple comparison test).(n=3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BAFCDB2-0511-4B2E-839E-17501F7BA249}"/>
              </a:ext>
            </a:extLst>
          </p:cNvPr>
          <p:cNvSpPr txBox="1"/>
          <p:nvPr/>
        </p:nvSpPr>
        <p:spPr>
          <a:xfrm rot="16200000">
            <a:off x="-670707" y="2152755"/>
            <a:ext cx="26476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 of EGFP (RFU)</a:t>
            </a:r>
          </a:p>
        </p:txBody>
      </p:sp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F97DC25E-2B87-4E9F-8F9C-4ED7AA8F006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37541723"/>
              </p:ext>
            </p:extLst>
          </p:nvPr>
        </p:nvGraphicFramePr>
        <p:xfrm>
          <a:off x="1211104" y="874970"/>
          <a:ext cx="4710112" cy="34861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0753174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>
  <documentManagement>
    <DocumentType xmlns="131e10da-a4e4-4a1d-8e0e-8b1c452cb3ff">Presentation</DocumentType>
    <DocumentId xmlns="131e10da-a4e4-4a1d-8e0e-8b1c452cb3ff">Presentation 4.PPTX</DocumentId>
    <FileFormat xmlns="131e10da-a4e4-4a1d-8e0e-8b1c452cb3ff">PPTX</FileFormat>
    <IsDeleted xmlns="131e10da-a4e4-4a1d-8e0e-8b1c452cb3ff">false</IsDeleted>
    <Checked_x0020_Out_x0020_To xmlns="131e10da-a4e4-4a1d-8e0e-8b1c452cb3ff">
      <UserInfo>
        <DisplayName/>
        <AccountId xsi:nil="true"/>
        <AccountType/>
      </UserInfo>
    </Checked_x0020_Out_x0020_To>
    <StageName xmlns="131e10da-a4e4-4a1d-8e0e-8b1c452cb3ff" xsi:nil="true"/>
    <TitleName xmlns="131e10da-a4e4-4a1d-8e0e-8b1c452cb3ff">Presentation 4.PPTX</TitleName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C2C48B24435E340B497488822270BF3" ma:contentTypeVersion="7" ma:contentTypeDescription="Create a new document." ma:contentTypeScope="" ma:versionID="b32f383984273fa14c2baa3789e4b90d">
  <xsd:schema xmlns:xsd="http://www.w3.org/2001/XMLSchema" xmlns:p="http://schemas.microsoft.com/office/2006/metadata/properties" xmlns:ns2="131e10da-a4e4-4a1d-8e0e-8b1c452cb3ff" targetNamespace="http://schemas.microsoft.com/office/2006/metadata/properties" ma:root="true" ma:fieldsID="2aa968b53266efd9fd45ce8759341b8c" ns2:_="">
    <xsd:import namespace="131e10da-a4e4-4a1d-8e0e-8b1c452cb3ff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131e10da-a4e4-4a1d-8e0e-8b1c452cb3ff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Props1.xml><?xml version="1.0" encoding="utf-8"?>
<ds:datastoreItem xmlns:ds="http://schemas.openxmlformats.org/officeDocument/2006/customXml" ds:itemID="{73628086-31FF-43F6-85AE-110ACC2E8E09}">
  <ds:schemaRefs>
    <ds:schemaRef ds:uri="http://schemas.openxmlformats.org/package/2006/metadata/core-properties"/>
    <ds:schemaRef ds:uri="http://purl.org/dc/terms/"/>
    <ds:schemaRef ds:uri="http://schemas.microsoft.com/office/2006/documentManagement/types"/>
    <ds:schemaRef ds:uri="http://schemas.microsoft.com/office/2006/metadata/properties"/>
    <ds:schemaRef ds:uri="http://purl.org/dc/elements/1.1/"/>
    <ds:schemaRef ds:uri="131e10da-a4e4-4a1d-8e0e-8b1c452cb3ff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AAD125DF-1EBA-477E-AB2F-F9C343E0E870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6DC6079-E14E-4C46-835F-6AF97BFE89A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31e10da-a4e4-4a1d-8e0e-8b1c452cb3ff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1</Words>
  <Application>Microsoft Office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康之</dc:creator>
  <cp:lastModifiedBy>Sidra Amiri</cp:lastModifiedBy>
  <cp:revision>10</cp:revision>
  <dcterms:created xsi:type="dcterms:W3CDTF">2017-11-29T06:46:27Z</dcterms:created>
  <dcterms:modified xsi:type="dcterms:W3CDTF">2018-02-02T12:57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C2C48B24435E340B497488822270BF3</vt:lpwstr>
  </property>
</Properties>
</file>